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2" d="100"/>
          <a:sy n="82" d="100"/>
        </p:scale>
        <p:origin x="691"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765A2F-4794-4C6A-85AE-8CF3380F279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6ED6358-D08D-4C62-BC3F-9ADE7EC157F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C118D55-45E0-4C16-B0FD-4735165D2798}"/>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5" name="Footer Placeholder 4">
            <a:extLst>
              <a:ext uri="{FF2B5EF4-FFF2-40B4-BE49-F238E27FC236}">
                <a16:creationId xmlns:a16="http://schemas.microsoft.com/office/drawing/2014/main" id="{47137BD5-02C0-478F-8E04-68C5A1E68F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A604F7A-B8B4-4451-A81C-786F8D7E51F7}"/>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41189976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62E626-F426-4077-B28A-A0ECC912C82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CFC2526-8765-4276-813D-178D64FE875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69CF331-EA62-4EB9-B276-630992527CFC}"/>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5" name="Footer Placeholder 4">
            <a:extLst>
              <a:ext uri="{FF2B5EF4-FFF2-40B4-BE49-F238E27FC236}">
                <a16:creationId xmlns:a16="http://schemas.microsoft.com/office/drawing/2014/main" id="{22AE31F2-4D0E-4D30-800C-34B053378B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DDDC1B-0112-4EFB-B1CC-45CCC064169B}"/>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6246471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10EBEE2-E769-4821-8044-829A50306DE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4AE0286-AF6B-4B30-978F-C03F52BBACC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371A561-D32E-4254-8B4A-8FEB348B3A63}"/>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5" name="Footer Placeholder 4">
            <a:extLst>
              <a:ext uri="{FF2B5EF4-FFF2-40B4-BE49-F238E27FC236}">
                <a16:creationId xmlns:a16="http://schemas.microsoft.com/office/drawing/2014/main" id="{76E7193F-FA30-400D-A1B6-F659F44E14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48952E8-4743-4D46-8133-21C03D322CC2}"/>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8071916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371FCC-30C6-4E59-924C-E12A454ACB0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FE300A4-B7A2-4AD3-BF43-E38A12B9FBB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C57F6E9-027A-49C5-B480-55DF84C5E621}"/>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5" name="Footer Placeholder 4">
            <a:extLst>
              <a:ext uri="{FF2B5EF4-FFF2-40B4-BE49-F238E27FC236}">
                <a16:creationId xmlns:a16="http://schemas.microsoft.com/office/drawing/2014/main" id="{74F7B8F6-5F69-4661-A8B0-365A59998E4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5073A62-B562-4AC9-8310-6D4C0B354ECC}"/>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22689401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39DA45-132F-499E-8CE5-A1DF82B3BEA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8189DAB-DFC4-436B-8602-C03038ABA97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8BE3CA6-FC36-4F8F-92C6-ED91DC2AB7A4}"/>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5" name="Footer Placeholder 4">
            <a:extLst>
              <a:ext uri="{FF2B5EF4-FFF2-40B4-BE49-F238E27FC236}">
                <a16:creationId xmlns:a16="http://schemas.microsoft.com/office/drawing/2014/main" id="{35D2F32F-7CDF-45D6-A347-C9A847A863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EDE107A-5E5D-4FDE-ACFD-746E97C7647A}"/>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28876853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51F6EB-FCA4-4651-A60C-436DEA40940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0450630-7D6D-4917-9C91-FF98510B23C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9053636-0358-4898-A383-657526F1AAB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092C006-0341-402A-975C-C02895F3744C}"/>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6" name="Footer Placeholder 5">
            <a:extLst>
              <a:ext uri="{FF2B5EF4-FFF2-40B4-BE49-F238E27FC236}">
                <a16:creationId xmlns:a16="http://schemas.microsoft.com/office/drawing/2014/main" id="{4E973F24-1B4F-45EB-B79D-C52382FE94A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EEFF48-63E5-494F-B1B1-6DC0BFAEE5BF}"/>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35649358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AF67E9-4385-4368-9F0A-2BB99BC12DA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77E6A5C-EF7B-4DE4-80F5-30C6D36BCF0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13F25B2-0245-48E3-AF95-EC16963FC49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3E66C50-D4C0-4D05-A6DF-82E1B1263FC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C74A43A-E2E2-4406-9894-666DB20CCC4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80F9D5F-FD9B-4ED0-8BBB-2D3B1A20D1B6}"/>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8" name="Footer Placeholder 7">
            <a:extLst>
              <a:ext uri="{FF2B5EF4-FFF2-40B4-BE49-F238E27FC236}">
                <a16:creationId xmlns:a16="http://schemas.microsoft.com/office/drawing/2014/main" id="{1B2895F4-335D-490B-84C5-9CC82A9ED00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E9D121B-C342-4818-995A-BAC2BFDE7511}"/>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9496242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644FEA-63DC-4F3C-B44C-29F163677C1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3A26E87-F130-44B3-80DD-5D8528F154D4}"/>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4" name="Footer Placeholder 3">
            <a:extLst>
              <a:ext uri="{FF2B5EF4-FFF2-40B4-BE49-F238E27FC236}">
                <a16:creationId xmlns:a16="http://schemas.microsoft.com/office/drawing/2014/main" id="{25D8EB42-213C-49B0-BF94-4154C20C46A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A118D19-CE83-4CA9-B2DA-F1145743C99D}"/>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17021100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9AFD60D-6495-4779-8A50-DD39B3E7A70E}"/>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3" name="Footer Placeholder 2">
            <a:extLst>
              <a:ext uri="{FF2B5EF4-FFF2-40B4-BE49-F238E27FC236}">
                <a16:creationId xmlns:a16="http://schemas.microsoft.com/office/drawing/2014/main" id="{6362677C-7ADF-47F4-8D5D-653E263019C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BD080D0-F499-457B-97F2-3C58833D806D}"/>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34347943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1E0832-783D-47EA-A149-291E7FC924F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76F947B-B97D-42E4-B907-44BF531F65A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88873DB-4A0B-4573-B4B7-C1AAB6F9B4C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4397BCA-57B3-40E4-90F9-E8DCF7D7338E}"/>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6" name="Footer Placeholder 5">
            <a:extLst>
              <a:ext uri="{FF2B5EF4-FFF2-40B4-BE49-F238E27FC236}">
                <a16:creationId xmlns:a16="http://schemas.microsoft.com/office/drawing/2014/main" id="{E8406A84-8045-4AC0-82A4-7F6840A1340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1B56C1B-1FBB-4EED-AB86-22A21CAF2114}"/>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20252434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E70543-0058-4B2E-9233-DEAC25CBA14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C7736C4-BBC8-4B97-98F3-FC351ECBDB8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A9C09A8-DD98-4541-969B-FA65AADABF4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FF807B3-871A-43B0-8F1A-76A7D351BE6C}"/>
              </a:ext>
            </a:extLst>
          </p:cNvPr>
          <p:cNvSpPr>
            <a:spLocks noGrp="1"/>
          </p:cNvSpPr>
          <p:nvPr>
            <p:ph type="dt" sz="half" idx="10"/>
          </p:nvPr>
        </p:nvSpPr>
        <p:spPr/>
        <p:txBody>
          <a:bodyPr/>
          <a:lstStyle/>
          <a:p>
            <a:fld id="{499BFD5B-A43E-46A1-9554-44CBEF449D3B}" type="datetimeFigureOut">
              <a:rPr lang="en-US" smtClean="0"/>
              <a:t>7/20/2021</a:t>
            </a:fld>
            <a:endParaRPr lang="en-US"/>
          </a:p>
        </p:txBody>
      </p:sp>
      <p:sp>
        <p:nvSpPr>
          <p:cNvPr id="6" name="Footer Placeholder 5">
            <a:extLst>
              <a:ext uri="{FF2B5EF4-FFF2-40B4-BE49-F238E27FC236}">
                <a16:creationId xmlns:a16="http://schemas.microsoft.com/office/drawing/2014/main" id="{DDD0927E-D6D1-4321-9E08-9969D1B4B9E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2A2257F-1BB7-40E1-AA84-14499604AFDE}"/>
              </a:ext>
            </a:extLst>
          </p:cNvPr>
          <p:cNvSpPr>
            <a:spLocks noGrp="1"/>
          </p:cNvSpPr>
          <p:nvPr>
            <p:ph type="sldNum" sz="quarter" idx="12"/>
          </p:nvPr>
        </p:nvSpPr>
        <p:spPr/>
        <p:txBody>
          <a:bodyPr/>
          <a:lstStyle/>
          <a:p>
            <a:fld id="{50D3DFD1-29AF-45C3-A0A0-B04BE2E2B749}" type="slidenum">
              <a:rPr lang="en-US" smtClean="0"/>
              <a:t>‹#›</a:t>
            </a:fld>
            <a:endParaRPr lang="en-US"/>
          </a:p>
        </p:txBody>
      </p:sp>
    </p:spTree>
    <p:extLst>
      <p:ext uri="{BB962C8B-B14F-4D97-AF65-F5344CB8AC3E}">
        <p14:creationId xmlns:p14="http://schemas.microsoft.com/office/powerpoint/2010/main" val="6907447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85C6A41-A383-4C7E-BF2A-9DCFC3719B7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6D72CF6-D662-402F-9710-FD28B6E79CF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1BCDE4-4F10-4B3B-89DE-3E669151A9E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99BFD5B-A43E-46A1-9554-44CBEF449D3B}" type="datetimeFigureOut">
              <a:rPr lang="en-US" smtClean="0"/>
              <a:t>7/20/2021</a:t>
            </a:fld>
            <a:endParaRPr lang="en-US"/>
          </a:p>
        </p:txBody>
      </p:sp>
      <p:sp>
        <p:nvSpPr>
          <p:cNvPr id="5" name="Footer Placeholder 4">
            <a:extLst>
              <a:ext uri="{FF2B5EF4-FFF2-40B4-BE49-F238E27FC236}">
                <a16:creationId xmlns:a16="http://schemas.microsoft.com/office/drawing/2014/main" id="{E0B240B8-C35A-4BBB-A01F-FC363AF1118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76A9372-6106-4A51-BAC8-0FB87846DE9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0D3DFD1-29AF-45C3-A0A0-B04BE2E2B749}" type="slidenum">
              <a:rPr lang="en-US" smtClean="0"/>
              <a:t>‹#›</a:t>
            </a:fld>
            <a:endParaRPr lang="en-US"/>
          </a:p>
        </p:txBody>
      </p:sp>
    </p:spTree>
    <p:extLst>
      <p:ext uri="{BB962C8B-B14F-4D97-AF65-F5344CB8AC3E}">
        <p14:creationId xmlns:p14="http://schemas.microsoft.com/office/powerpoint/2010/main" val="19759804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73E5FD1-FB92-4DA3-AF52-1A27AE1FD32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57527" y="1488931"/>
            <a:ext cx="5169159" cy="5145133"/>
          </a:xfrm>
          <a:prstGeom prst="rect">
            <a:avLst/>
          </a:prstGeom>
        </p:spPr>
      </p:pic>
      <p:pic>
        <p:nvPicPr>
          <p:cNvPr id="4" name="Picture 3">
            <a:extLst>
              <a:ext uri="{FF2B5EF4-FFF2-40B4-BE49-F238E27FC236}">
                <a16:creationId xmlns:a16="http://schemas.microsoft.com/office/drawing/2014/main" id="{29F62F50-D39C-4AF0-9A44-5F98B5381DBE}"/>
              </a:ext>
            </a:extLst>
          </p:cNvPr>
          <p:cNvPicPr>
            <a:picLocks noChangeAspect="1"/>
          </p:cNvPicPr>
          <p:nvPr/>
        </p:nvPicPr>
        <p:blipFill>
          <a:blip r:embed="rId3"/>
          <a:stretch>
            <a:fillRect/>
          </a:stretch>
        </p:blipFill>
        <p:spPr>
          <a:xfrm>
            <a:off x="65314" y="946541"/>
            <a:ext cx="6830008" cy="5955572"/>
          </a:xfrm>
          <a:prstGeom prst="rect">
            <a:avLst/>
          </a:prstGeom>
        </p:spPr>
      </p:pic>
      <p:sp>
        <p:nvSpPr>
          <p:cNvPr id="6" name="TextBox 5">
            <a:extLst>
              <a:ext uri="{FF2B5EF4-FFF2-40B4-BE49-F238E27FC236}">
                <a16:creationId xmlns:a16="http://schemas.microsoft.com/office/drawing/2014/main" id="{37287F7B-E2C1-4B15-AD68-ABB4260617D4}"/>
              </a:ext>
            </a:extLst>
          </p:cNvPr>
          <p:cNvSpPr txBox="1"/>
          <p:nvPr/>
        </p:nvSpPr>
        <p:spPr>
          <a:xfrm>
            <a:off x="0" y="0"/>
            <a:ext cx="12126686" cy="946541"/>
          </a:xfrm>
          <a:prstGeom prst="rect">
            <a:avLst/>
          </a:prstGeom>
          <a:noFill/>
        </p:spPr>
        <p:txBody>
          <a:bodyPr wrap="square">
            <a:spAutoFit/>
          </a:bodyPr>
          <a:lstStyle/>
          <a:p>
            <a:pPr marL="0" marR="0" algn="just">
              <a:lnSpc>
                <a:spcPct val="107000"/>
              </a:lnSpc>
              <a:spcBef>
                <a:spcPts val="0"/>
              </a:spcBef>
              <a:spcAft>
                <a:spcPts val="800"/>
              </a:spcAft>
            </a:pPr>
            <a:r>
              <a:rPr lang="en-US" sz="1200" b="1" dirty="0">
                <a:effectLst/>
                <a:latin typeface="Times New Roman" panose="02020603050405020304" pitchFamily="18" charset="0"/>
                <a:ea typeface="Calibri" panose="020F0502020204030204" pitchFamily="34" charset="0"/>
              </a:rPr>
              <a:t>Supplementary Figure 3</a:t>
            </a:r>
            <a:endParaRPr lang="en-US" sz="1200" dirty="0">
              <a:effectLst/>
              <a:latin typeface="Times New Roman" panose="02020603050405020304" pitchFamily="18" charset="0"/>
              <a:ea typeface="Calibri" panose="020F0502020204030204" pitchFamily="34" charset="0"/>
            </a:endParaRPr>
          </a:p>
          <a:p>
            <a:r>
              <a:rPr lang="en-US" sz="1200" dirty="0">
                <a:effectLst/>
                <a:latin typeface="Times New Roman" panose="02020603050405020304" pitchFamily="18" charset="0"/>
                <a:ea typeface="Calibri" panose="020F0502020204030204" pitchFamily="34" charset="0"/>
              </a:rPr>
              <a:t>Principal component analysis of basic pI proteins of virus proteomes originated from a different host. Analysis revealed the basic </a:t>
            </a:r>
            <a:r>
              <a:rPr lang="en-US" sz="1200" i="1" dirty="0">
                <a:effectLst/>
                <a:latin typeface="Times New Roman" panose="02020603050405020304" pitchFamily="18" charset="0"/>
                <a:ea typeface="Calibri" panose="020F0502020204030204" pitchFamily="34" charset="0"/>
              </a:rPr>
              <a:t>pI</a:t>
            </a:r>
            <a:r>
              <a:rPr lang="en-US" sz="1200" dirty="0">
                <a:effectLst/>
                <a:latin typeface="Times New Roman" panose="02020603050405020304" pitchFamily="18" charset="0"/>
                <a:ea typeface="Calibri" panose="020F0502020204030204" pitchFamily="34" charset="0"/>
              </a:rPr>
              <a:t> proteins of viruses originated from host invertebrates, algae, protozoa, and archaea clustered together reflecting their close resemblance. The basic pI protein of human and fungi fall distantly. Heat map of the basic </a:t>
            </a:r>
            <a:r>
              <a:rPr lang="en-US" sz="1200" i="1" dirty="0">
                <a:effectLst/>
                <a:latin typeface="Times New Roman" panose="02020603050405020304" pitchFamily="18" charset="0"/>
                <a:ea typeface="Calibri" panose="020F0502020204030204" pitchFamily="34" charset="0"/>
              </a:rPr>
              <a:t>pI</a:t>
            </a:r>
            <a:r>
              <a:rPr lang="en-US" sz="1200" dirty="0">
                <a:effectLst/>
                <a:latin typeface="Times New Roman" panose="02020603050405020304" pitchFamily="18" charset="0"/>
                <a:ea typeface="Calibri" panose="020F0502020204030204" pitchFamily="34" charset="0"/>
              </a:rPr>
              <a:t> protein shows a positive correlation and none of them was found negatively correlated.</a:t>
            </a:r>
            <a:endParaRPr lang="en-US" sz="1200" dirty="0"/>
          </a:p>
        </p:txBody>
      </p:sp>
    </p:spTree>
    <p:extLst>
      <p:ext uri="{BB962C8B-B14F-4D97-AF65-F5344CB8AC3E}">
        <p14:creationId xmlns:p14="http://schemas.microsoft.com/office/powerpoint/2010/main" val="12539382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7</TotalTime>
  <Words>76</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hanta Tapan</dc:creator>
  <cp:lastModifiedBy>HP</cp:lastModifiedBy>
  <cp:revision>6</cp:revision>
  <dcterms:created xsi:type="dcterms:W3CDTF">2021-04-07T06:10:46Z</dcterms:created>
  <dcterms:modified xsi:type="dcterms:W3CDTF">2021-07-20T04:50:37Z</dcterms:modified>
</cp:coreProperties>
</file>